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6858000" cy="9144000" type="letter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2814" autoAdjust="0"/>
  </p:normalViewPr>
  <p:slideViewPr>
    <p:cSldViewPr>
      <p:cViewPr varScale="1">
        <p:scale>
          <a:sx n="86" d="100"/>
          <a:sy n="86" d="100"/>
        </p:scale>
        <p:origin x="3186" y="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137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188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4576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969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3936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4666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885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8629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5350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178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8114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506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93842653"/>
              </p:ext>
            </p:extLst>
          </p:nvPr>
        </p:nvGraphicFramePr>
        <p:xfrm>
          <a:off x="3648456" y="1428748"/>
          <a:ext cx="3209544" cy="33073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0" name="SPW 13.0 Graph" r:id="rId3" imgW="5884252" imgH="6064148" progId="SigmaPlotGraphicObject.12">
                  <p:embed/>
                </p:oleObj>
              </mc:Choice>
              <mc:Fallback>
                <p:oleObj name="SPW 13.0 Graph" r:id="rId3" imgW="5884252" imgH="6064148" progId="SigmaPlotGraphicObjec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648456" y="1428748"/>
                        <a:ext cx="3209544" cy="33073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35678515"/>
              </p:ext>
            </p:extLst>
          </p:nvPr>
        </p:nvGraphicFramePr>
        <p:xfrm>
          <a:off x="-1279861" y="1219200"/>
          <a:ext cx="4556461" cy="28205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1" name="SPW 13.0 Graph" r:id="rId5" imgW="8395819" imgH="5198201" progId="SigmaPlotGraphicObject.12">
                  <p:embed/>
                </p:oleObj>
              </mc:Choice>
              <mc:Fallback>
                <p:oleObj name="SPW 13.0 Graph" r:id="rId5" imgW="8395819" imgH="5198201" progId="SigmaPlotGraphicObjec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-1279861" y="1219200"/>
                        <a:ext cx="4556461" cy="28205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609600" y="4419600"/>
            <a:ext cx="552720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 Fig.  Effect of global post-natal reductions in ATX on liver gene expression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ne expression in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dark bars) and MX1-Δ (open bars) male mice (n =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3). 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2713542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5</TotalTime>
  <Words>37</Words>
  <Application>Microsoft Office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Office Theme</vt:lpstr>
      <vt:lpstr>SPW 13.0 Graph</vt:lpstr>
      <vt:lpstr>PowerPoint Presentation</vt:lpstr>
    </vt:vector>
  </TitlesOfParts>
  <Company>University of Kentuck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myth, Susan</dc:creator>
  <cp:lastModifiedBy>McMullen, Colleen</cp:lastModifiedBy>
  <cp:revision>15</cp:revision>
  <cp:lastPrinted>2018-10-21T18:40:01Z</cp:lastPrinted>
  <dcterms:created xsi:type="dcterms:W3CDTF">2018-10-08T19:40:09Z</dcterms:created>
  <dcterms:modified xsi:type="dcterms:W3CDTF">2018-11-15T15:13:30Z</dcterms:modified>
</cp:coreProperties>
</file>